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5" autoAdjust="0"/>
    <p:restoredTop sz="94660"/>
  </p:normalViewPr>
  <p:slideViewPr>
    <p:cSldViewPr snapToGrid="0">
      <p:cViewPr varScale="1">
        <p:scale>
          <a:sx n="124" d="100"/>
          <a:sy n="124" d="100"/>
        </p:scale>
        <p:origin x="245" y="10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EF96-F51F-4962-9B96-5C0B8DD5FB9A}" type="datetimeFigureOut">
              <a:rPr lang="en-US" smtClean="0"/>
              <a:t>5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9081-F0EE-4D63-BD92-D1069DC2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345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EF96-F51F-4962-9B96-5C0B8DD5FB9A}" type="datetimeFigureOut">
              <a:rPr lang="en-US" smtClean="0"/>
              <a:t>5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9081-F0EE-4D63-BD92-D1069DC2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327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EF96-F51F-4962-9B96-5C0B8DD5FB9A}" type="datetimeFigureOut">
              <a:rPr lang="en-US" smtClean="0"/>
              <a:t>5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9081-F0EE-4D63-BD92-D1069DC2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31400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EF96-F51F-4962-9B96-5C0B8DD5FB9A}" type="datetimeFigureOut">
              <a:rPr lang="en-US" smtClean="0"/>
              <a:t>5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9081-F0EE-4D63-BD92-D1069DC2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388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EF96-F51F-4962-9B96-5C0B8DD5FB9A}" type="datetimeFigureOut">
              <a:rPr lang="en-US" smtClean="0"/>
              <a:t>5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9081-F0EE-4D63-BD92-D1069DC2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066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EF96-F51F-4962-9B96-5C0B8DD5FB9A}" type="datetimeFigureOut">
              <a:rPr lang="en-US" smtClean="0"/>
              <a:t>5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9081-F0EE-4D63-BD92-D1069DC2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0559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EF96-F51F-4962-9B96-5C0B8DD5FB9A}" type="datetimeFigureOut">
              <a:rPr lang="en-US" smtClean="0"/>
              <a:t>5/1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9081-F0EE-4D63-BD92-D1069DC2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700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EF96-F51F-4962-9B96-5C0B8DD5FB9A}" type="datetimeFigureOut">
              <a:rPr lang="en-US" smtClean="0"/>
              <a:t>5/1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9081-F0EE-4D63-BD92-D1069DC2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68373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EF96-F51F-4962-9B96-5C0B8DD5FB9A}" type="datetimeFigureOut">
              <a:rPr lang="en-US" smtClean="0"/>
              <a:t>5/1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9081-F0EE-4D63-BD92-D1069DC2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82902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EF96-F51F-4962-9B96-5C0B8DD5FB9A}" type="datetimeFigureOut">
              <a:rPr lang="en-US" smtClean="0"/>
              <a:t>5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9081-F0EE-4D63-BD92-D1069DC2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889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EF96-F51F-4962-9B96-5C0B8DD5FB9A}" type="datetimeFigureOut">
              <a:rPr lang="en-US" smtClean="0"/>
              <a:t>5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C9081-F0EE-4D63-BD92-D1069DC2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453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D5EF96-F51F-4962-9B96-5C0B8DD5FB9A}" type="datetimeFigureOut">
              <a:rPr lang="en-US" smtClean="0"/>
              <a:t>5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3C9081-F0EE-4D63-BD92-D1069DC2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867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62862" y="6349114"/>
            <a:ext cx="80284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Palatino Linotype" panose="02040502050505030304" pitchFamily="18" charset="0"/>
              </a:rPr>
              <a:t>Information compiled from [5] with reference to Online Mendelian Inheritance in Man (OMIM) Fibrllin1 database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15976397"/>
              </p:ext>
            </p:extLst>
          </p:nvPr>
        </p:nvGraphicFramePr>
        <p:xfrm>
          <a:off x="2515664" y="274272"/>
          <a:ext cx="6522828" cy="5923996"/>
        </p:xfrm>
        <a:graphic>
          <a:graphicData uri="http://schemas.openxmlformats.org/drawingml/2006/table">
            <a:tbl>
              <a:tblPr/>
              <a:tblGrid>
                <a:gridCol w="825413">
                  <a:extLst>
                    <a:ext uri="{9D8B030D-6E8A-4147-A177-3AD203B41FA5}">
                      <a16:colId xmlns:a16="http://schemas.microsoft.com/office/drawing/2014/main" val="89808097"/>
                    </a:ext>
                  </a:extLst>
                </a:gridCol>
                <a:gridCol w="1031631">
                  <a:extLst>
                    <a:ext uri="{9D8B030D-6E8A-4147-A177-3AD203B41FA5}">
                      <a16:colId xmlns:a16="http://schemas.microsoft.com/office/drawing/2014/main" val="1933631269"/>
                    </a:ext>
                  </a:extLst>
                </a:gridCol>
                <a:gridCol w="3985846">
                  <a:extLst>
                    <a:ext uri="{9D8B030D-6E8A-4147-A177-3AD203B41FA5}">
                      <a16:colId xmlns:a16="http://schemas.microsoft.com/office/drawing/2014/main" val="1769078727"/>
                    </a:ext>
                  </a:extLst>
                </a:gridCol>
                <a:gridCol w="679938">
                  <a:extLst>
                    <a:ext uri="{9D8B030D-6E8A-4147-A177-3AD203B41FA5}">
                      <a16:colId xmlns:a16="http://schemas.microsoft.com/office/drawing/2014/main" val="2496840901"/>
                    </a:ext>
                  </a:extLst>
                </a:gridCol>
              </a:tblGrid>
              <a:tr h="3238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Gene symbol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8E8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Gene name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8E8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yndrome &amp; Phenotype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8E8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OMIM number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8E8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6951016"/>
                  </a:ext>
                </a:extLst>
              </a:tr>
              <a:tr h="72609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BN1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8E8E8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ibrillin1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8E8E8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arfan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syndrome: aortic dilatation &amp; dissection,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ectopia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lentis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, skeletal abnormalities including arachnodactyly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8E8E8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54700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8E8E8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1227531"/>
                  </a:ext>
                </a:extLst>
              </a:tr>
              <a:tr h="5177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BN1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ibrillin1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arfan syndrome (autosomal recessive; heterozygotes show no signs or symptoms of Marfan syndrome)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54700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4893499"/>
                  </a:ext>
                </a:extLst>
              </a:tr>
              <a:tr h="3525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BN1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ibrillin1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Ectopia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lenti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29600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2448504"/>
                  </a:ext>
                </a:extLst>
              </a:tr>
              <a:tr h="36355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BN1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ibrillin1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scending aortic aneurysm and dissection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36" marR="4436" marT="4436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5261959"/>
                  </a:ext>
                </a:extLst>
              </a:tr>
              <a:tr h="47372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BN1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ibrillin1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ASS syndrome: involvement of mitral valve, aorta, skeleton, and skin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04308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7436604"/>
                  </a:ext>
                </a:extLst>
              </a:tr>
              <a:tr h="66101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BN1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ibrillin1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hprintzen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Goldberg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raniosynostosis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syndrome: arachnodactyly, maxillary and mandibular hypoplasia, multiple abdominal hernias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82212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9110490"/>
                  </a:ext>
                </a:extLst>
              </a:tr>
              <a:tr h="36355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BN1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ibrillin1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tiff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skin syndrome: flexion contractures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84900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7764997"/>
                  </a:ext>
                </a:extLst>
              </a:tr>
              <a:tr h="6610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BN1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ibrillin1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Weill-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archesani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syndrome 2 (autosomal dominant): short stature,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brachydactyly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, joint stiffness, eye abnormalities including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ectopia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lenti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08328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9947779"/>
                  </a:ext>
                </a:extLst>
              </a:tr>
              <a:tr h="62796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BN1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ibrillin1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cromicric dysplasia: severe short stature, short extremities, stiff joints, distinct skeletal features, pseudomuscular build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2370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7365892"/>
                  </a:ext>
                </a:extLst>
              </a:tr>
              <a:tr h="8065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BN1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ibrillin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Geleophysic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dysplasia 2: short stature, short extremities, stiff joints with contractures, cardiac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valvular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thickening, respiratory insufficiency, lean body habitus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14185</a:t>
                      </a:r>
                    </a:p>
                  </a:txBody>
                  <a:tcPr marL="4436" marR="4436" marT="44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5600101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637270" y="-61240"/>
            <a:ext cx="92366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Table S1: Inherited disorders associated with pathogenic variants in FBN1.</a:t>
            </a:r>
          </a:p>
        </p:txBody>
      </p:sp>
    </p:spTree>
    <p:extLst>
      <p:ext uri="{BB962C8B-B14F-4D97-AF65-F5344CB8AC3E}">
        <p14:creationId xmlns:p14="http://schemas.microsoft.com/office/powerpoint/2010/main" val="39591764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70</TotalTime>
  <Words>206</Words>
  <Application>Microsoft Office PowerPoint</Application>
  <PresentationFormat>Widescreen</PresentationFormat>
  <Paragraphs>4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P</dc:creator>
  <cp:lastModifiedBy>MDPI</cp:lastModifiedBy>
  <cp:revision>48</cp:revision>
  <dcterms:created xsi:type="dcterms:W3CDTF">2024-03-11T19:10:37Z</dcterms:created>
  <dcterms:modified xsi:type="dcterms:W3CDTF">2024-05-17T02:19:32Z</dcterms:modified>
</cp:coreProperties>
</file>